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64" r:id="rId2"/>
    <p:sldId id="266" r:id="rId3"/>
    <p:sldId id="263" r:id="rId4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39"/>
    <p:restoredTop sz="94647"/>
  </p:normalViewPr>
  <p:slideViewPr>
    <p:cSldViewPr snapToGrid="0" snapToObjects="1">
      <p:cViewPr varScale="1">
        <p:scale>
          <a:sx n="91" d="100"/>
          <a:sy n="91" d="100"/>
        </p:scale>
        <p:origin x="200" y="136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17F3D52-4340-1F4A-8ED0-430AD7D7C563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4F2A49BE-FA39-004E-ADCE-F904E5656007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0C4BE72-2660-3149-85C4-9FBB4455071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D48DB8-8049-CE41-BAB8-DD821559C7BB}" type="datetimeFigureOut">
              <a:rPr lang="en-US" smtClean="0"/>
              <a:t>6/2/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6BC258A-26FA-514B-8516-7CC84E2EFC4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5A7875C-7A09-9245-BE20-7B957E65E53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902443-C886-034F-A6E8-A314F5E253E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1184994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F962B17-15BC-244E-AE56-F99C87091E5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F0F7B886-F662-114E-9CD5-C5DA878CCD4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9631FCD-6F29-0E44-B2C9-EF42E9089BF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D48DB8-8049-CE41-BAB8-DD821559C7BB}" type="datetimeFigureOut">
              <a:rPr lang="en-US" smtClean="0"/>
              <a:t>6/2/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F9C4D41-3F37-104F-9E35-4C50D0F1412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78ACE01-CDC7-A144-B7FE-1F560176EFD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902443-C886-034F-A6E8-A314F5E253E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4434983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4095BCEF-9255-D64B-B40E-8D5DF71D84C3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E5540761-702F-7F49-B1B9-9ABC83A2AAF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A6D6514-14B7-B742-ADA3-5865121C7C0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D48DB8-8049-CE41-BAB8-DD821559C7BB}" type="datetimeFigureOut">
              <a:rPr lang="en-US" smtClean="0"/>
              <a:t>6/2/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DA8CD68-CA01-7041-8617-0F9D924302E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B3FED3F-9576-DC4C-B23B-E8DB05749B4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902443-C886-034F-A6E8-A314F5E253E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9109535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C479ED4-0DB4-8B46-893B-6EE95582745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8BE8C91-517D-C240-9E5D-7032BAF9F702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19CDC8F-190C-8C46-B753-D07BDB79353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D48DB8-8049-CE41-BAB8-DD821559C7BB}" type="datetimeFigureOut">
              <a:rPr lang="en-US" smtClean="0"/>
              <a:t>6/2/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A877FE6-03F3-FD49-9104-8801FEB2C79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2425A14-F48E-F84D-8DF6-07A8CCA1A5D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902443-C886-034F-A6E8-A314F5E253E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7853440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92CF7B4-87BB-7740-8376-53DDA55F5ED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736F5FA-8A3C-A144-9A27-B5FE75791FF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EF6891C-CCFA-AA41-BEC4-461AD78892D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D48DB8-8049-CE41-BAB8-DD821559C7BB}" type="datetimeFigureOut">
              <a:rPr lang="en-US" smtClean="0"/>
              <a:t>6/2/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3BF8086-F09C-C547-A385-1F37C38A969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B962B4B-8F7D-4946-9D27-0D648FCD831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902443-C886-034F-A6E8-A314F5E253E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0836571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8761BAF-144A-594D-B1A8-A175F046BA1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EA5CD0A-0997-B24D-838C-B39A38611571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0013F88C-0E98-924C-B89B-6FB1909EA54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DE2613EC-6813-7746-900C-EC416EC1012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D48DB8-8049-CE41-BAB8-DD821559C7BB}" type="datetimeFigureOut">
              <a:rPr lang="en-US" smtClean="0"/>
              <a:t>6/2/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E3393ED-8656-E849-8652-C14CB8A9852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8419F5C-00AE-2841-9FD2-EB7F2347305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902443-C886-034F-A6E8-A314F5E253E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8146194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C8718AB-3E61-8845-9A86-833CFE0C478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43C1818-D6B8-6540-B8EA-084B945709D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01847490-2972-C944-86FA-1EE2AC88C3C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AC39E95B-AE8B-004F-A959-A32CDFE361C1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57630227-A8C2-8045-8B2F-E5FF97E285F8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146E09D6-B057-3548-908B-A428D890680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D48DB8-8049-CE41-BAB8-DD821559C7BB}" type="datetimeFigureOut">
              <a:rPr lang="en-US" smtClean="0"/>
              <a:t>6/2/20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614B0378-C103-694D-8B25-3DBBE36C1A4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12169DBB-82CD-7A44-AE42-2A1424D0737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902443-C886-034F-A6E8-A314F5E253E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1928540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A983E01-4ED8-9E4A-9313-FA76E3473C0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C336B1A3-D25C-8948-9D32-A309EAFCD08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D48DB8-8049-CE41-BAB8-DD821559C7BB}" type="datetimeFigureOut">
              <a:rPr lang="en-US" smtClean="0"/>
              <a:t>6/2/20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DB1B47B1-C04D-B64D-A55B-C83A872E563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58443EC4-498B-1E4C-87E3-046DF704081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902443-C886-034F-A6E8-A314F5E253E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5462668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60A88A74-63A0-F64D-908B-E0EF6AEE5E2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D48DB8-8049-CE41-BAB8-DD821559C7BB}" type="datetimeFigureOut">
              <a:rPr lang="en-US" smtClean="0"/>
              <a:t>6/2/20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F5B5BBFB-59D2-5F4A-B382-9B06F5712E5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2F59E7EF-14FB-CC42-B665-EA476E6B103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902443-C886-034F-A6E8-A314F5E253E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3249661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882CF19-23B3-1949-94F6-7C2FB7AA9B5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86DB4A3-8C08-AA4C-9AF8-C2C3431A33DC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D6D95EC0-B93D-C24A-8F5F-27DED8A9DAB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C6B9136-5A2C-2142-8E34-DFEECEEA99C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D48DB8-8049-CE41-BAB8-DD821559C7BB}" type="datetimeFigureOut">
              <a:rPr lang="en-US" smtClean="0"/>
              <a:t>6/2/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057549B-F260-8242-ACAB-457E8F226DD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DE41BC2-5D0A-104A-B2E3-DAC1FC3FF53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902443-C886-034F-A6E8-A314F5E253E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8998051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03A7C87-B466-9045-910E-5B3E79A4748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6DCD40B0-4AB4-2A4B-B95C-2DB7A35D3B7C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0AFABE7D-6B08-CE45-AA8C-5BDAC4DE79A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A5B288B-87C3-FA4F-A8FE-41B215C4378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D48DB8-8049-CE41-BAB8-DD821559C7BB}" type="datetimeFigureOut">
              <a:rPr lang="en-US" smtClean="0"/>
              <a:t>6/2/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E9F5D43-5684-AB4B-8825-B6602FCB89F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E958B39-A9C9-0F4F-8A57-18E690F3F9C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902443-C886-034F-A6E8-A314F5E253E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4994212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20CE9D22-C0B6-0C45-AFDC-2DE44DEF09A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0900A79-AF38-4E47-B92D-10AAB901077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0575805-85A9-5041-8F16-115BBBB3A76D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1D48DB8-8049-CE41-BAB8-DD821559C7BB}" type="datetimeFigureOut">
              <a:rPr lang="en-US" smtClean="0"/>
              <a:t>6/2/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D50BE95-9DFB-8644-85DA-6CD38E8BA5D5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8BE12BB-1E22-3043-A129-450B22AC7839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D902443-C886-034F-A6E8-A314F5E253E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9283911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tiff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tif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1662E08A-8CF0-964A-A229-FA23719EBA4C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928468" y="186396"/>
            <a:ext cx="9959926" cy="5877989"/>
          </a:xfrm>
          <a:prstGeom prst="rect">
            <a:avLst/>
          </a:prstGeom>
        </p:spPr>
      </p:pic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A8A073B-EA85-4B45-8F2B-7DC8D1822DC5}"/>
              </a:ext>
            </a:extLst>
          </p:cNvPr>
          <p:cNvSpPr txBox="1">
            <a:spLocks/>
          </p:cNvSpPr>
          <p:nvPr/>
        </p:nvSpPr>
        <p:spPr>
          <a:xfrm>
            <a:off x="650631" y="6064385"/>
            <a:ext cx="10515600" cy="826599"/>
          </a:xfrm>
          <a:prstGeom prst="rect">
            <a:avLst/>
          </a:prstGeom>
        </p:spPr>
        <p:txBody>
          <a:bodyPr>
            <a:normAutofit/>
          </a:bodyPr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>
              <a:buNone/>
            </a:pPr>
            <a:r>
              <a:rPr lang="en-US" sz="1800" dirty="0">
                <a:latin typeface="Cambria" panose="02040503050406030204" pitchFamily="18" charset="0"/>
              </a:rPr>
              <a:t>Figure E1. Temporal trends of all-cause mortality stratified by age group. </a:t>
            </a:r>
          </a:p>
        </p:txBody>
      </p:sp>
    </p:spTree>
    <p:extLst>
      <p:ext uri="{BB962C8B-B14F-4D97-AF65-F5344CB8AC3E}">
        <p14:creationId xmlns:p14="http://schemas.microsoft.com/office/powerpoint/2010/main" val="292823804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A8A073B-EA85-4B45-8F2B-7DC8D1822DC5}"/>
              </a:ext>
            </a:extLst>
          </p:cNvPr>
          <p:cNvSpPr txBox="1">
            <a:spLocks/>
          </p:cNvSpPr>
          <p:nvPr/>
        </p:nvSpPr>
        <p:spPr>
          <a:xfrm>
            <a:off x="650631" y="6064385"/>
            <a:ext cx="10515600" cy="826599"/>
          </a:xfrm>
          <a:prstGeom prst="rect">
            <a:avLst/>
          </a:prstGeom>
        </p:spPr>
        <p:txBody>
          <a:bodyPr>
            <a:normAutofit/>
          </a:bodyPr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>
              <a:buNone/>
            </a:pPr>
            <a:r>
              <a:rPr lang="en-US" sz="1800" dirty="0">
                <a:latin typeface="Cambria" panose="02040503050406030204" pitchFamily="18" charset="0"/>
              </a:rPr>
              <a:t>Figure E2. Temporal trends of MV therapy rate stratified by presence of respiratory failure. </a:t>
            </a: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E56CCF13-0A14-3946-AB6E-483E0A7A7D8E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211580" y="242668"/>
            <a:ext cx="9393701" cy="554382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49606430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4436ECD-BB9C-AD49-AC1F-4B87F42A7AE4}"/>
              </a:ext>
            </a:extLst>
          </p:cNvPr>
          <p:cNvSpPr txBox="1">
            <a:spLocks/>
          </p:cNvSpPr>
          <p:nvPr/>
        </p:nvSpPr>
        <p:spPr>
          <a:xfrm>
            <a:off x="944392" y="5901224"/>
            <a:ext cx="10515600" cy="854734"/>
          </a:xfrm>
          <a:prstGeom prst="rect">
            <a:avLst/>
          </a:prstGeom>
        </p:spPr>
        <p:txBody>
          <a:bodyPr>
            <a:normAutofit/>
          </a:bodyPr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>
              <a:buNone/>
            </a:pPr>
            <a:r>
              <a:rPr lang="en-US" sz="1800">
                <a:latin typeface="Cambria" panose="02040503050406030204" pitchFamily="18" charset="0"/>
              </a:rPr>
              <a:t>Figure E3. </a:t>
            </a:r>
            <a:r>
              <a:rPr lang="en-US" sz="1800" dirty="0">
                <a:latin typeface="Cambria" panose="02040503050406030204" pitchFamily="18" charset="0"/>
              </a:rPr>
              <a:t>Receiver operator curve for the regression model. </a:t>
            </a: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8EC02330-1EE5-C645-87AE-E435FFE2E3F3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294227" y="370084"/>
            <a:ext cx="8918917" cy="526362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57302474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56</TotalTime>
  <Words>40</Words>
  <Application>Microsoft Macintosh PowerPoint</Application>
  <PresentationFormat>Widescreen</PresentationFormat>
  <Paragraphs>3</Paragraphs>
  <Slides>3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8" baseType="lpstr">
      <vt:lpstr>Arial</vt:lpstr>
      <vt:lpstr>Calibri</vt:lpstr>
      <vt:lpstr>Calibri Light</vt:lpstr>
      <vt:lpstr>Cambria</vt:lpstr>
      <vt:lpstr>Office Theme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lqalyoobi, Shehabaldin</dc:creator>
  <cp:lastModifiedBy>Alqalyoobi, Shehabaldin</cp:lastModifiedBy>
  <cp:revision>23</cp:revision>
  <dcterms:created xsi:type="dcterms:W3CDTF">2020-05-12T05:16:40Z</dcterms:created>
  <dcterms:modified xsi:type="dcterms:W3CDTF">2020-06-02T09:59:15Z</dcterms:modified>
</cp:coreProperties>
</file>